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CAD48B-11AC-4B14-9EA4-07AD71D2AE2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60361B-374E-46DC-BB93-CEDBD36EB7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EAAB25-E88B-4EE9-B816-3FCB0636D88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BF486D-4A28-489F-83E9-2C7F2F884E4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B2A0F7-4DB3-43FD-BB5C-9240B47386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24BE87-81F1-412E-8C77-0C2103D15E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48DD11-3E92-4299-9357-AB66C5A514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7E82BF-A5E7-4991-B53A-03BF5DF634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152F97-7FEF-4D35-91FB-38F942984E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5871CF-9005-4AF9-B2A2-CBB1C9CA2F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37EE27-377E-47D9-A429-0AF6ADEEF2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8E7237-CBF2-4B49-BD83-A859D6B9D9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74704C9-E3A8-4D3F-809A-FCD7529265B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84"/>
          <p:cNvGrpSpPr/>
          <p:nvPr/>
        </p:nvGrpSpPr>
        <p:grpSpPr>
          <a:xfrm>
            <a:off x="1504800" y="301680"/>
            <a:ext cx="4667040" cy="3047760"/>
            <a:chOff x="1504800" y="301680"/>
            <a:chExt cx="4667040" cy="3047760"/>
          </a:xfrm>
        </p:grpSpPr>
        <p:pic>
          <p:nvPicPr>
            <p:cNvPr id="42" name="Picture 85" descr=""/>
            <p:cNvPicPr/>
            <p:nvPr/>
          </p:nvPicPr>
          <p:blipFill>
            <a:blip r:embed="rId1"/>
            <a:stretch/>
          </p:blipFill>
          <p:spPr>
            <a:xfrm>
              <a:off x="1504800" y="301680"/>
              <a:ext cx="4667040" cy="30477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3" name="Group 11"/>
            <p:cNvGrpSpPr/>
            <p:nvPr/>
          </p:nvGrpSpPr>
          <p:grpSpPr>
            <a:xfrm>
              <a:off x="2351880" y="3003120"/>
              <a:ext cx="3128760" cy="276480"/>
              <a:chOff x="2351880" y="3003120"/>
              <a:chExt cx="3128760" cy="276480"/>
            </a:xfrm>
          </p:grpSpPr>
          <p:sp>
            <p:nvSpPr>
              <p:cNvPr id="44" name="AutoShape 38"/>
              <p:cNvSpPr/>
              <p:nvPr/>
            </p:nvSpPr>
            <p:spPr>
              <a:xfrm rot="16200000">
                <a:off x="3078720" y="2312640"/>
                <a:ext cx="32760" cy="1486440"/>
              </a:xfrm>
              <a:custGeom>
                <a:avLst/>
                <a:gdLst>
                  <a:gd name="textAreaLeft" fmla="*/ 9720 w 32760"/>
                  <a:gd name="textAreaRight" fmla="*/ 33120 w 32760"/>
                  <a:gd name="textAreaTop" fmla="*/ 40320 h 1486440"/>
                  <a:gd name="textAreaBottom" fmla="*/ 1446120 h 14864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0800" y="0"/>
                      <a:pt x="0" y="587"/>
                      <a:pt x="0" y="1173"/>
                    </a:cubicBezTo>
                    <a:lnTo>
                      <a:pt x="0" y="20427"/>
                    </a:lnTo>
                    <a:cubicBezTo>
                      <a:pt x="0" y="21014"/>
                      <a:pt x="108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 rot="10800000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" name="Text Box 40"/>
              <p:cNvSpPr/>
              <p:nvPr/>
            </p:nvSpPr>
            <p:spPr>
              <a:xfrm>
                <a:off x="2562120" y="3003120"/>
                <a:ext cx="2918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76NE6                               TDCs   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" name="AutoShape 38"/>
              <p:cNvSpPr/>
              <p:nvPr/>
            </p:nvSpPr>
            <p:spPr>
              <a:xfrm rot="16200000">
                <a:off x="4580280" y="2301120"/>
                <a:ext cx="32760" cy="1486440"/>
              </a:xfrm>
              <a:custGeom>
                <a:avLst/>
                <a:gdLst>
                  <a:gd name="textAreaLeft" fmla="*/ 9720 w 32760"/>
                  <a:gd name="textAreaRight" fmla="*/ 33120 w 32760"/>
                  <a:gd name="textAreaTop" fmla="*/ 40320 h 1486440"/>
                  <a:gd name="textAreaBottom" fmla="*/ 1446120 h 14864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0800" y="0"/>
                      <a:pt x="0" y="587"/>
                      <a:pt x="0" y="1173"/>
                    </a:cubicBezTo>
                    <a:lnTo>
                      <a:pt x="0" y="20427"/>
                    </a:lnTo>
                    <a:cubicBezTo>
                      <a:pt x="0" y="21014"/>
                      <a:pt x="108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 rot="10800000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47" name="Text Box 23"/>
            <p:cNvSpPr/>
            <p:nvPr/>
          </p:nvSpPr>
          <p:spPr>
            <a:xfrm>
              <a:off x="2949120" y="870840"/>
              <a:ext cx="793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 anchorCtr="1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 = 0.00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Line 36"/>
            <p:cNvSpPr/>
            <p:nvPr/>
          </p:nvSpPr>
          <p:spPr>
            <a:xfrm>
              <a:off x="3052080" y="1053720"/>
              <a:ext cx="557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Line 38"/>
            <p:cNvSpPr/>
            <p:nvPr/>
          </p:nvSpPr>
          <p:spPr>
            <a:xfrm>
              <a:off x="3057120" y="1049760"/>
              <a:ext cx="0" cy="1052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Line 38"/>
            <p:cNvSpPr/>
            <p:nvPr/>
          </p:nvSpPr>
          <p:spPr>
            <a:xfrm>
              <a:off x="3599640" y="1051560"/>
              <a:ext cx="0" cy="88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1" name="Text Box 28"/>
          <p:cNvSpPr/>
          <p:nvPr/>
        </p:nvSpPr>
        <p:spPr>
          <a:xfrm>
            <a:off x="1600200" y="304920"/>
            <a:ext cx="509760" cy="509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6560" rIns="106560" tIns="53280" bIns="5328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1066680"/>
                <a:tab algn="l" pos="2133720"/>
                <a:tab algn="l" pos="3200400"/>
                <a:tab algn="l" pos="4267080"/>
                <a:tab algn="l" pos="5334120"/>
                <a:tab algn="l" pos="6400800"/>
                <a:tab algn="l" pos="7467480"/>
                <a:tab algn="l" pos="8534520"/>
                <a:tab algn="l" pos="9601200"/>
                <a:tab algn="l" pos="106678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25"/>
          <p:cNvSpPr/>
          <p:nvPr/>
        </p:nvSpPr>
        <p:spPr>
          <a:xfrm>
            <a:off x="0" y="304920"/>
            <a:ext cx="175248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31"/>
          <p:cNvSpPr/>
          <p:nvPr/>
        </p:nvSpPr>
        <p:spPr>
          <a:xfrm>
            <a:off x="1143000" y="7804080"/>
            <a:ext cx="571500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Figure 19: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LMW-E activates gene expression associated with the EM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(A – F) Cells were grown in monolayer culture to 70% confluency and RNA were extracted and subjected to qRT-PCR analysis for the mRNA levels of cyclin E (A), E-cadherin (B), twist (C), vimentin (D), N-cadherin (E), and slug (F). These values were normalized against GAPDH mRNA levels and statistical analysis used was unpaired student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’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test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31"/>
          <p:cNvSpPr/>
          <p:nvPr/>
        </p:nvSpPr>
        <p:spPr>
          <a:xfrm>
            <a:off x="1295280" y="7956720"/>
            <a:ext cx="571500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Figure 19: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LMW-E activates gene expression associated with the EM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(A – F) Cells were grown in monolayer culture to 70% confluency and RNA were extracted and subjected to qRT-PCR analysis for the mRNA levels of cyclin E (A), E-cadherin (B), twist (C), vimentin (D), N-cadherin (E), and slug (F). These values were normalized against GAPDH mRNA levels and statistical analysis used was unpaired student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’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test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31"/>
          <p:cNvSpPr/>
          <p:nvPr/>
        </p:nvSpPr>
        <p:spPr>
          <a:xfrm>
            <a:off x="1447920" y="8109000"/>
            <a:ext cx="571500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Figure 19: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LMW-E activates gene expression associated with the EM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(A – F) Cells were grown in monolayer culture to 70% confluency and RNA were extracted and subjected to qRT-PCR analysis for the mRNA levels of cyclin E (A), E-cadherin (B), twist (C), vimentin (D), N-cadherin (E), and slug (F). These values were normalized against GAPDH mRNA levels and statistical analysis used was unpaired student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’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test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 Box 78"/>
          <p:cNvSpPr/>
          <p:nvPr/>
        </p:nvSpPr>
        <p:spPr>
          <a:xfrm rot="16200000">
            <a:off x="737280" y="1663920"/>
            <a:ext cx="19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elative mRNA level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7" name="Picture 17" descr=""/>
          <p:cNvPicPr/>
          <p:nvPr/>
        </p:nvPicPr>
        <p:blipFill>
          <a:blip r:embed="rId2"/>
          <a:stretch/>
        </p:blipFill>
        <p:spPr>
          <a:xfrm>
            <a:off x="299880" y="3645000"/>
            <a:ext cx="4584960" cy="2755800"/>
          </a:xfrm>
          <a:prstGeom prst="rect">
            <a:avLst/>
          </a:prstGeom>
          <a:ln w="0">
            <a:noFill/>
          </a:ln>
        </p:spPr>
      </p:pic>
      <p:grpSp>
        <p:nvGrpSpPr>
          <p:cNvPr id="58" name="Group 18"/>
          <p:cNvGrpSpPr/>
          <p:nvPr/>
        </p:nvGrpSpPr>
        <p:grpSpPr>
          <a:xfrm>
            <a:off x="5295960" y="4021200"/>
            <a:ext cx="3848040" cy="2311200"/>
            <a:chOff x="5295960" y="4021200"/>
            <a:chExt cx="3848040" cy="2311200"/>
          </a:xfrm>
        </p:grpSpPr>
        <p:pic>
          <p:nvPicPr>
            <p:cNvPr id="59" name="Picture 20" descr=""/>
            <p:cNvPicPr/>
            <p:nvPr/>
          </p:nvPicPr>
          <p:blipFill>
            <a:blip r:embed="rId3"/>
            <a:stretch/>
          </p:blipFill>
          <p:spPr>
            <a:xfrm>
              <a:off x="5295960" y="4021200"/>
              <a:ext cx="3848040" cy="2311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0" name="Straight Connector 21"/>
            <p:cNvSpPr/>
            <p:nvPr/>
          </p:nvSpPr>
          <p:spPr>
            <a:xfrm>
              <a:off x="6443640" y="5421240"/>
              <a:ext cx="0" cy="11412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Straight Connector 22"/>
            <p:cNvSpPr/>
            <p:nvPr/>
          </p:nvSpPr>
          <p:spPr>
            <a:xfrm>
              <a:off x="8158320" y="4186080"/>
              <a:ext cx="0" cy="628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Straight Connector 23"/>
            <p:cNvSpPr/>
            <p:nvPr/>
          </p:nvSpPr>
          <p:spPr>
            <a:xfrm>
              <a:off x="6391080" y="5415120"/>
              <a:ext cx="11412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Straight Connector 24"/>
            <p:cNvSpPr/>
            <p:nvPr/>
          </p:nvSpPr>
          <p:spPr>
            <a:xfrm>
              <a:off x="8102520" y="4186080"/>
              <a:ext cx="11268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4" name="Rectangle 25"/>
          <p:cNvSpPr/>
          <p:nvPr/>
        </p:nvSpPr>
        <p:spPr>
          <a:xfrm>
            <a:off x="152280" y="3276720"/>
            <a:ext cx="259092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1f497d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1f497d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 Box 78"/>
          <p:cNvSpPr/>
          <p:nvPr/>
        </p:nvSpPr>
        <p:spPr>
          <a:xfrm rot="16200000">
            <a:off x="-743400" y="4794480"/>
            <a:ext cx="19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elative mRNA level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 Box 78"/>
          <p:cNvSpPr/>
          <p:nvPr/>
        </p:nvSpPr>
        <p:spPr>
          <a:xfrm rot="16200000">
            <a:off x="4170960" y="4871160"/>
            <a:ext cx="191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elative mRNA level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01T16:43:56Z</dcterms:created>
  <dc:creator>Khandan Keyomarsi</dc:creator>
  <dc:description/>
  <dc:language>en-US</dc:language>
  <cp:lastModifiedBy>Khandan Keyomarsi</cp:lastModifiedBy>
  <dcterms:modified xsi:type="dcterms:W3CDTF">2011-12-01T16:44:46Z</dcterms:modified>
  <cp:revision>1</cp:revision>
  <dc:subject/>
  <dc:title>PowerPoint Presentation</dc:title>
</cp:coreProperties>
</file>